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ddar, Binata" initials="JB" lastIdx="5" clrIdx="0">
    <p:extLst>
      <p:ext uri="{19B8F6BF-5375-455C-9EA6-DF929625EA0E}">
        <p15:presenceInfo xmlns:p15="http://schemas.microsoft.com/office/powerpoint/2012/main" userId="S-1-5-21-24445035-1449287043-316617838-391784" providerId="AD"/>
      </p:ext>
    </p:extLst>
  </p:cmAuthor>
  <p:cmAuthor id="2" name="Nishat Tasnim" initials="NT" lastIdx="1" clrIdx="1">
    <p:extLst>
      <p:ext uri="{19B8F6BF-5375-455C-9EA6-DF929625EA0E}">
        <p15:presenceInfo xmlns:p15="http://schemas.microsoft.com/office/powerpoint/2012/main" userId="Nishat Tasnim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132" autoAdjust="0"/>
    <p:restoredTop sz="94660"/>
  </p:normalViewPr>
  <p:slideViewPr>
    <p:cSldViewPr snapToGrid="0">
      <p:cViewPr varScale="1">
        <p:scale>
          <a:sx n="72" d="100"/>
          <a:sy n="72" d="100"/>
        </p:scale>
        <p:origin x="57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4414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938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6719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0331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5659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08869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0522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072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11773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4685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94465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697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02" name="Picture 6" descr="D:\Study Material\PhD\Project\Images\10042016\QS_3304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5078" y="692429"/>
            <a:ext cx="4218925" cy="316419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842053" y="4159405"/>
            <a:ext cx="881269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ALP-stained mouse MSC indicates pluripotency of cells used for all experiments. Scale bar is 30 µm in all images.</a:t>
            </a:r>
            <a:endParaRPr lang="en-US" dirty="0"/>
          </a:p>
          <a:p>
            <a:pPr algn="just"/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Straight Connector 11"/>
          <p:cNvCxnSpPr/>
          <p:nvPr/>
        </p:nvCxnSpPr>
        <p:spPr>
          <a:xfrm>
            <a:off x="6746359" y="3548346"/>
            <a:ext cx="310896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575275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64</TotalTime>
  <Words>2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ddar, Binata</dc:creator>
  <cp:lastModifiedBy>Nishat Tasnim</cp:lastModifiedBy>
  <cp:revision>69</cp:revision>
  <dcterms:created xsi:type="dcterms:W3CDTF">2017-11-07T18:52:12Z</dcterms:created>
  <dcterms:modified xsi:type="dcterms:W3CDTF">2018-05-22T17:06:27Z</dcterms:modified>
</cp:coreProperties>
</file>